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3" r:id="rId3"/>
    <p:sldId id="264" r:id="rId4"/>
    <p:sldId id="265" r:id="rId5"/>
    <p:sldId id="266" r:id="rId6"/>
    <p:sldId id="267" r:id="rId7"/>
    <p:sldId id="268" r:id="rId8"/>
    <p:sldId id="269" r:id="rId9"/>
    <p:sldId id="270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isa Zanini" userId="ae649509-4456-4ee5-8edf-9faece1dadd7" providerId="ADAL" clId="{11DA6881-BAD9-4EA5-8CA3-DAF81F6F3816}"/>
    <pc:docChg chg="delSld">
      <pc:chgData name="Elisa Zanini" userId="ae649509-4456-4ee5-8edf-9faece1dadd7" providerId="ADAL" clId="{11DA6881-BAD9-4EA5-8CA3-DAF81F6F3816}" dt="2024-05-23T09:43:40.846" v="0" actId="47"/>
      <pc:docMkLst>
        <pc:docMk/>
      </pc:docMkLst>
      <pc:sldChg chg="del">
        <pc:chgData name="Elisa Zanini" userId="ae649509-4456-4ee5-8edf-9faece1dadd7" providerId="ADAL" clId="{11DA6881-BAD9-4EA5-8CA3-DAF81F6F3816}" dt="2024-05-23T09:43:40.846" v="0" actId="47"/>
        <pc:sldMkLst>
          <pc:docMk/>
          <pc:sldMk cId="3859893126" sldId="256"/>
        </pc:sldMkLst>
      </pc:sldChg>
      <pc:sldChg chg="del">
        <pc:chgData name="Elisa Zanini" userId="ae649509-4456-4ee5-8edf-9faece1dadd7" providerId="ADAL" clId="{11DA6881-BAD9-4EA5-8CA3-DAF81F6F3816}" dt="2024-05-23T09:43:40.846" v="0" actId="47"/>
        <pc:sldMkLst>
          <pc:docMk/>
          <pc:sldMk cId="2872132823" sldId="257"/>
        </pc:sldMkLst>
      </pc:sldChg>
      <pc:sldChg chg="del">
        <pc:chgData name="Elisa Zanini" userId="ae649509-4456-4ee5-8edf-9faece1dadd7" providerId="ADAL" clId="{11DA6881-BAD9-4EA5-8CA3-DAF81F6F3816}" dt="2024-05-23T09:43:40.846" v="0" actId="47"/>
        <pc:sldMkLst>
          <pc:docMk/>
          <pc:sldMk cId="3855629589" sldId="258"/>
        </pc:sldMkLst>
      </pc:sldChg>
      <pc:sldChg chg="del">
        <pc:chgData name="Elisa Zanini" userId="ae649509-4456-4ee5-8edf-9faece1dadd7" providerId="ADAL" clId="{11DA6881-BAD9-4EA5-8CA3-DAF81F6F3816}" dt="2024-05-23T09:43:40.846" v="0" actId="47"/>
        <pc:sldMkLst>
          <pc:docMk/>
          <pc:sldMk cId="3649345038" sldId="259"/>
        </pc:sldMkLst>
      </pc:sldChg>
      <pc:sldChg chg="del">
        <pc:chgData name="Elisa Zanini" userId="ae649509-4456-4ee5-8edf-9faece1dadd7" providerId="ADAL" clId="{11DA6881-BAD9-4EA5-8CA3-DAF81F6F3816}" dt="2024-05-23T09:43:40.846" v="0" actId="47"/>
        <pc:sldMkLst>
          <pc:docMk/>
          <pc:sldMk cId="66736082" sldId="260"/>
        </pc:sldMkLst>
      </pc:sldChg>
      <pc:sldChg chg="del">
        <pc:chgData name="Elisa Zanini" userId="ae649509-4456-4ee5-8edf-9faece1dadd7" providerId="ADAL" clId="{11DA6881-BAD9-4EA5-8CA3-DAF81F6F3816}" dt="2024-05-23T09:43:40.846" v="0" actId="47"/>
        <pc:sldMkLst>
          <pc:docMk/>
          <pc:sldMk cId="2186888472" sldId="26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77553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5384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415667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95530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57300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339408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245860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746296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475086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879247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666442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4FB9B-ADE6-4344-B36E-88C4435394A2}" type="datetimeFigureOut">
              <a:rPr lang="LID4096" smtClean="0"/>
              <a:t>05/23/2024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4531A-11B2-40DB-AFB4-6E5C60FA18A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567926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CB6B46F-2FCD-1AD8-495D-4A5546A80B62}"/>
              </a:ext>
            </a:extLst>
          </p:cNvPr>
          <p:cNvSpPr txBox="1"/>
          <p:nvPr/>
        </p:nvSpPr>
        <p:spPr>
          <a:xfrm>
            <a:off x="0" y="-100613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+mn-lt"/>
              </a:rPr>
              <a:t>Supplementary Table 1</a:t>
            </a:r>
            <a:endParaRPr lang="en-US" sz="1400" dirty="0">
              <a:latin typeface="+mn-lt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864083F-57A3-CFCB-D3FA-8CCC093A9D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355" y="323054"/>
            <a:ext cx="5639289" cy="7181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6210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68BE3D3-9D87-BDCA-04A6-3798681FEA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7701" y="5190756"/>
            <a:ext cx="2183627" cy="29518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71B9FFC-0391-B41B-E2ED-903E5CD6F9D5}"/>
              </a:ext>
            </a:extLst>
          </p:cNvPr>
          <p:cNvSpPr txBox="1"/>
          <p:nvPr/>
        </p:nvSpPr>
        <p:spPr>
          <a:xfrm>
            <a:off x="319173" y="5127289"/>
            <a:ext cx="410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(D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E69AA49-3D73-AFAC-01DF-5929DB594844}"/>
              </a:ext>
            </a:extLst>
          </p:cNvPr>
          <p:cNvSpPr txBox="1"/>
          <p:nvPr/>
        </p:nvSpPr>
        <p:spPr>
          <a:xfrm>
            <a:off x="3812133" y="5127289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(E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7863F7-0266-B40F-CBB7-206682039985}"/>
              </a:ext>
            </a:extLst>
          </p:cNvPr>
          <p:cNvSpPr txBox="1"/>
          <p:nvPr/>
        </p:nvSpPr>
        <p:spPr>
          <a:xfrm>
            <a:off x="319173" y="560512"/>
            <a:ext cx="405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(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7F9A4E-753F-E4DF-0FC2-573F68EF6942}"/>
              </a:ext>
            </a:extLst>
          </p:cNvPr>
          <p:cNvSpPr txBox="1"/>
          <p:nvPr/>
        </p:nvSpPr>
        <p:spPr>
          <a:xfrm>
            <a:off x="3812133" y="565445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(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F7A200A-092F-E1D5-5A6E-5DE430B51406}"/>
              </a:ext>
            </a:extLst>
          </p:cNvPr>
          <p:cNvSpPr txBox="1"/>
          <p:nvPr/>
        </p:nvSpPr>
        <p:spPr>
          <a:xfrm>
            <a:off x="1107765" y="3008784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(C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C4743F3-4AAB-AEAD-CE11-6125B41FF3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2851" y="714277"/>
            <a:ext cx="2620754" cy="210556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145C2E6-AFE6-A69C-CE3D-132406778F0A}"/>
              </a:ext>
            </a:extLst>
          </p:cNvPr>
          <p:cNvSpPr txBox="1"/>
          <p:nvPr/>
        </p:nvSpPr>
        <p:spPr>
          <a:xfrm>
            <a:off x="319173" y="6622491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(F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C5BB136-C073-627F-9AD6-1A6C73951F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9309" y="6753200"/>
            <a:ext cx="2884896" cy="158417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DAF3E73-E881-73B1-9244-F675B23D46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4784" y="3122116"/>
            <a:ext cx="4671486" cy="190932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39D9941-467A-9353-2635-EA00159F54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7795" y="5230309"/>
            <a:ext cx="2738151" cy="134092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F5ED48A-CA69-21A6-53DD-74E4A98B8B5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56445" y="895308"/>
            <a:ext cx="2272769" cy="141135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E30BF28-9DEF-F3FB-962E-2869F3D697A1}"/>
              </a:ext>
            </a:extLst>
          </p:cNvPr>
          <p:cNvSpPr txBox="1"/>
          <p:nvPr/>
        </p:nvSpPr>
        <p:spPr>
          <a:xfrm>
            <a:off x="19844" y="18604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030573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FDA404C-E07C-2123-D8DE-20A4DC358E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8720" y="1770127"/>
            <a:ext cx="4610901" cy="25922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E2C9741-E029-3840-8076-3BC18B1D58B1}"/>
              </a:ext>
            </a:extLst>
          </p:cNvPr>
          <p:cNvSpPr txBox="1"/>
          <p:nvPr/>
        </p:nvSpPr>
        <p:spPr>
          <a:xfrm>
            <a:off x="19844" y="18604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5880994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AEB9CB8-4344-E1EF-BD4C-4329E28711F1}"/>
              </a:ext>
            </a:extLst>
          </p:cNvPr>
          <p:cNvSpPr txBox="1"/>
          <p:nvPr/>
        </p:nvSpPr>
        <p:spPr>
          <a:xfrm>
            <a:off x="19844" y="18604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Tabl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7F27B6F-1FC2-F9FD-98CF-FA0F590866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409" y="776579"/>
            <a:ext cx="3097036" cy="24508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2762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8140581-FBA0-B29B-1509-F72B47A84C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749" y="1175049"/>
            <a:ext cx="5968501" cy="209720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FCABB3D-CA16-40C7-9802-3D8F06EF8544}"/>
              </a:ext>
            </a:extLst>
          </p:cNvPr>
          <p:cNvSpPr txBox="1"/>
          <p:nvPr/>
        </p:nvSpPr>
        <p:spPr>
          <a:xfrm>
            <a:off x="19844" y="18604"/>
            <a:ext cx="188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Table 3</a:t>
            </a:r>
          </a:p>
        </p:txBody>
      </p:sp>
    </p:spTree>
    <p:extLst>
      <p:ext uri="{BB962C8B-B14F-4D97-AF65-F5344CB8AC3E}">
        <p14:creationId xmlns:p14="http://schemas.microsoft.com/office/powerpoint/2010/main" val="32308821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20479E-8C64-EB83-E96F-C08374D8E47B}"/>
              </a:ext>
            </a:extLst>
          </p:cNvPr>
          <p:cNvSpPr txBox="1"/>
          <p:nvPr/>
        </p:nvSpPr>
        <p:spPr>
          <a:xfrm>
            <a:off x="188640" y="10645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DC39E10-92F7-3D47-77D1-99716D8221E7}"/>
              </a:ext>
            </a:extLst>
          </p:cNvPr>
          <p:cNvSpPr txBox="1"/>
          <p:nvPr/>
        </p:nvSpPr>
        <p:spPr>
          <a:xfrm>
            <a:off x="2832875" y="10654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EBEFC5B-D0C2-A80C-C254-ABE604AE4C7A}"/>
              </a:ext>
            </a:extLst>
          </p:cNvPr>
          <p:cNvSpPr txBox="1"/>
          <p:nvPr/>
        </p:nvSpPr>
        <p:spPr>
          <a:xfrm>
            <a:off x="188640" y="327075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0B72C30-B92B-BC8E-3599-109BD7DE677B}"/>
              </a:ext>
            </a:extLst>
          </p:cNvPr>
          <p:cNvSpPr txBox="1"/>
          <p:nvPr/>
        </p:nvSpPr>
        <p:spPr>
          <a:xfrm>
            <a:off x="3022421" y="32770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518BB89-627E-DBB8-82DE-0EE8ACB586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294" y="1208584"/>
            <a:ext cx="6017274" cy="182895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199BF52-CB9E-1766-E79A-BC2B9ACD24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294" y="3435309"/>
            <a:ext cx="6261135" cy="187773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C442F1B-F1CC-54F9-8700-A24448823BC9}"/>
              </a:ext>
            </a:extLst>
          </p:cNvPr>
          <p:cNvSpPr txBox="1"/>
          <p:nvPr/>
        </p:nvSpPr>
        <p:spPr>
          <a:xfrm>
            <a:off x="19844" y="18604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5966565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C9C223A-B434-040B-E932-F072CEA7B5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737691" y="4132444"/>
            <a:ext cx="8083997" cy="138391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349487F-D367-1880-51A5-2FC63727C929}"/>
              </a:ext>
            </a:extLst>
          </p:cNvPr>
          <p:cNvSpPr txBox="1"/>
          <p:nvPr/>
        </p:nvSpPr>
        <p:spPr>
          <a:xfrm rot="5400000">
            <a:off x="2173451" y="4002723"/>
            <a:ext cx="68580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+mn-lt"/>
                <a:cs typeface="Times New Roman" panose="02020603050405020304" pitchFamily="18" charset="0"/>
              </a:rPr>
              <a:t>Study 1</a:t>
            </a:r>
            <a:endParaRPr lang="en-US" sz="11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CF164A8-0A58-B7EB-94DE-5B8D9301E41F}"/>
              </a:ext>
            </a:extLst>
          </p:cNvPr>
          <p:cNvSpPr txBox="1"/>
          <p:nvPr/>
        </p:nvSpPr>
        <p:spPr>
          <a:xfrm rot="5400000">
            <a:off x="331841" y="4008587"/>
            <a:ext cx="68580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+mn-lt"/>
                <a:cs typeface="Times New Roman" panose="02020603050405020304" pitchFamily="18" charset="0"/>
              </a:rPr>
              <a:t>Study 2</a:t>
            </a:r>
            <a:endParaRPr lang="en-US" sz="11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CC9A858-F9C2-D362-91BD-7A1CEA653D1C}"/>
              </a:ext>
            </a:extLst>
          </p:cNvPr>
          <p:cNvSpPr txBox="1"/>
          <p:nvPr/>
        </p:nvSpPr>
        <p:spPr>
          <a:xfrm>
            <a:off x="19844" y="18604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Table 4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BE01BCC-7E3E-A9E7-090A-68250BFD5E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-1750370" y="3541081"/>
            <a:ext cx="8083999" cy="25666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1261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03DB0C5-19F5-FF2B-44A8-7341AEB2FF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-730613" y="3617111"/>
            <a:ext cx="7943774" cy="20728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0DBA721-6868-4055-5E85-9520F39D1E44}"/>
              </a:ext>
            </a:extLst>
          </p:cNvPr>
          <p:cNvSpPr txBox="1"/>
          <p:nvPr/>
        </p:nvSpPr>
        <p:spPr>
          <a:xfrm>
            <a:off x="19844" y="18604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n-lt"/>
              </a:rPr>
              <a:t>Supplementary Table 5</a:t>
            </a:r>
          </a:p>
        </p:txBody>
      </p:sp>
    </p:spTree>
    <p:extLst>
      <p:ext uri="{BB962C8B-B14F-4D97-AF65-F5344CB8AC3E}">
        <p14:creationId xmlns:p14="http://schemas.microsoft.com/office/powerpoint/2010/main" val="3242767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6E27B2-40CF-B8EA-B044-9232C6CD9EE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0"/>
            <a:ext cx="0" cy="0"/>
          </a:xfrm>
        </p:spPr>
        <p:txBody>
          <a:bodyPr/>
          <a:lstStyle/>
          <a:p>
            <a:r>
              <a:rPr lang="en-US" dirty="0"/>
              <a:t>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180B2A2-EC9F-5E16-FC94-0F9D15CD797C}"/>
              </a:ext>
            </a:extLst>
          </p:cNvPr>
          <p:cNvSpPr txBox="1"/>
          <p:nvPr/>
        </p:nvSpPr>
        <p:spPr>
          <a:xfrm>
            <a:off x="0" y="10870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+mn-lt"/>
                <a:cs typeface="Times New Roman" panose="02020603050405020304" pitchFamily="18" charset="0"/>
              </a:rPr>
              <a:t>Supplementary Table 6</a:t>
            </a:r>
          </a:p>
        </p:txBody>
      </p:sp>
      <p:graphicFrame>
        <p:nvGraphicFramePr>
          <p:cNvPr id="7" name="object 2">
            <a:extLst>
              <a:ext uri="{FF2B5EF4-FFF2-40B4-BE49-F238E27FC236}">
                <a16:creationId xmlns:a16="http://schemas.microsoft.com/office/drawing/2014/main" id="{42CD796F-7247-0354-5DCD-60D15D8070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3923022"/>
              </p:ext>
            </p:extLst>
          </p:nvPr>
        </p:nvGraphicFramePr>
        <p:xfrm>
          <a:off x="17088" y="589093"/>
          <a:ext cx="6847839" cy="740283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756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65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9656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84568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91440">
                <a:tc>
                  <a:txBody>
                    <a:bodyPr/>
                    <a:lstStyle/>
                    <a:p>
                      <a:pPr marL="12700">
                        <a:lnSpc>
                          <a:spcPts val="565"/>
                        </a:lnSpc>
                        <a:spcBef>
                          <a:spcPts val="55"/>
                        </a:spcBef>
                      </a:pPr>
                      <a:r>
                        <a:rPr sz="500" b="1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500" b="1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b="1" spc="-20" dirty="0">
                          <a:latin typeface="Arial"/>
                          <a:cs typeface="Arial"/>
                        </a:rPr>
                        <a:t>l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27305" algn="ctr">
                        <a:lnSpc>
                          <a:spcPts val="565"/>
                        </a:lnSpc>
                        <a:spcBef>
                          <a:spcPts val="55"/>
                        </a:spcBef>
                      </a:pPr>
                      <a:r>
                        <a:rPr sz="500" b="1" spc="-10" dirty="0">
                          <a:latin typeface="Arial"/>
                          <a:cs typeface="Arial"/>
                        </a:rPr>
                        <a:t>Provider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65"/>
                        </a:lnSpc>
                        <a:spcBef>
                          <a:spcPts val="55"/>
                        </a:spcBef>
                      </a:pPr>
                      <a:r>
                        <a:rPr sz="500" b="1" dirty="0">
                          <a:latin typeface="Arial"/>
                          <a:cs typeface="Arial"/>
                        </a:rPr>
                        <a:t>Cat</a:t>
                      </a:r>
                      <a:r>
                        <a:rPr sz="500" b="1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b="1" spc="-50" dirty="0">
                          <a:latin typeface="Arial"/>
                          <a:cs typeface="Arial"/>
                        </a:rPr>
                        <a:t>#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" algn="ctr">
                        <a:lnSpc>
                          <a:spcPts val="565"/>
                        </a:lnSpc>
                        <a:spcBef>
                          <a:spcPts val="55"/>
                        </a:spcBef>
                      </a:pPr>
                      <a:r>
                        <a:rPr sz="500" b="1" spc="-25" dirty="0">
                          <a:latin typeface="Arial"/>
                          <a:cs typeface="Arial"/>
                        </a:rPr>
                        <a:t>Lot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65"/>
                        </a:lnSpc>
                        <a:spcBef>
                          <a:spcPts val="55"/>
                        </a:spcBef>
                      </a:pPr>
                      <a:r>
                        <a:rPr sz="500" b="1" spc="-10" dirty="0">
                          <a:latin typeface="Arial"/>
                          <a:cs typeface="Arial"/>
                        </a:rPr>
                        <a:t>Medium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7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769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P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952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7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952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7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93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952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7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952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786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O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93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233132/8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0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CH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61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5" dirty="0">
                          <a:latin typeface="Arial"/>
                          <a:cs typeface="Arial"/>
                        </a:rPr>
                        <a:t>AGS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igma/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909040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2H01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am’s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12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N3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C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1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B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45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BT47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am’s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12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BT54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2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5774112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0.023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U/mL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Insul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ki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4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ki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4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2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ACC45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ACC51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5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ACC30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5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6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4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yruvate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0.4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µg/mL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hydrocortisone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ng/mL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EGF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AMA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248698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LD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igm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LL0001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VL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Fu9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07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0313201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0.023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U/mL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Insul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G40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igm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LL0004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VL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C139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32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414672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C150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32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C193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33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471438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non-essential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amino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acid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C195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33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368108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yruvate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Hepes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C7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31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197834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yruvate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Hepes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T11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3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4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505613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CT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2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71062697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1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1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1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1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5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14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6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14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50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14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018201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5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Accege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BC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TC034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0904201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EC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11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G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9404225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7H07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HME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Lonz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55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7F328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EBM,</a:t>
                      </a:r>
                      <a:r>
                        <a:rPr sz="500" spc="1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ingleQuots</a:t>
                      </a:r>
                      <a:r>
                        <a:rPr sz="500" spc="1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growth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factors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RT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604030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2D00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s578T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2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308704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HS6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63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474891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s746T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3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7002163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T119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703240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T137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703240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HT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HT5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506110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IM9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07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0930201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0.023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U/mL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Insul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8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MSU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50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Kato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III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igma/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609300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3G01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KU-19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9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LoVo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3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2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403121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non-essential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amino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acid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LS174T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762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8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5762448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MCF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752996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yruvate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DA-M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3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762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506978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DA-M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45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3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401906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DA-M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46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3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5767541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MDST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9901180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3K00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FE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8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9805013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1J03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FE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9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9803110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2F03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NCI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H71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5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399005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NCI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N8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582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7001450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NUGC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082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1116201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OCUM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019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CC4</a:t>
                      </a:r>
                      <a:r>
                        <a:rPr sz="500" spc="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vector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igm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311270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ERF-G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100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0719201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5" dirty="0">
                          <a:latin typeface="Arial"/>
                          <a:cs typeface="Arial"/>
                        </a:rPr>
                        <a:t>RKO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57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230011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L95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2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67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213001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RT112/8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506110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5" dirty="0">
                          <a:latin typeface="Arial"/>
                          <a:cs typeface="Arial"/>
                        </a:rPr>
                        <a:t>RT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9109191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KBR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270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McCoy's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5A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SNG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M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JCR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JCRB017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0721200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am’s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12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NU1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597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SNU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4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KCLB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5" dirty="0">
                          <a:latin typeface="Arial"/>
                          <a:cs typeface="Arial"/>
                        </a:rPr>
                        <a:t>34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SW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71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42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W40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9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3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SW4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3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3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324784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4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W48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33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2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448773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non-essential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amino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acid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5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W62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2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5848316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L-Glutamine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EM</a:t>
                      </a:r>
                      <a:r>
                        <a:rPr sz="500" spc="11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NEAA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6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SW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780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2169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197834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7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SW948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CL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23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6252221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8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5" dirty="0">
                          <a:latin typeface="Arial"/>
                          <a:cs typeface="Arial"/>
                        </a:rPr>
                        <a:t>T2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76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5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9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T47D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TB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13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</a:t>
                      </a:r>
                      <a:r>
                        <a:rPr sz="500" spc="9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Sodium</a:t>
                      </a:r>
                      <a:r>
                        <a:rPr sz="500" spc="114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yruvat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0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5" dirty="0">
                          <a:latin typeface="Arial"/>
                          <a:cs typeface="Arial"/>
                        </a:rPr>
                        <a:t>T8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ECA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8802110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Ham’s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12,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2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Penicillin/Streptomycin,</a:t>
                      </a:r>
                      <a:r>
                        <a:rPr sz="500" spc="1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500" spc="8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Glutamine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1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TCC-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SUP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444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DSMZ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ACC</a:t>
                      </a:r>
                      <a:r>
                        <a:rPr sz="500" spc="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25" dirty="0">
                          <a:latin typeface="Arial"/>
                          <a:cs typeface="Arial"/>
                        </a:rPr>
                        <a:t>377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Lot</a:t>
                      </a:r>
                      <a:r>
                        <a:rPr sz="500" spc="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3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DMEM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5%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2"/>
                  </a:ext>
                </a:extLst>
              </a:tr>
              <a:tr h="88265"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10" dirty="0">
                          <a:latin typeface="Arial"/>
                          <a:cs typeface="Arial"/>
                        </a:rPr>
                        <a:t>ZR-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75-</a:t>
                      </a:r>
                      <a:r>
                        <a:rPr sz="500" spc="-50" dirty="0">
                          <a:latin typeface="Arial"/>
                          <a:cs typeface="Arial"/>
                        </a:rPr>
                        <a:t>1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spc="-20" dirty="0">
                          <a:latin typeface="Arial"/>
                          <a:cs typeface="Arial"/>
                        </a:rPr>
                        <a:t>ATCC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080" algn="ctr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CRL-</a:t>
                      </a:r>
                      <a:r>
                        <a:rPr sz="500" spc="-20" dirty="0">
                          <a:latin typeface="Arial"/>
                          <a:cs typeface="Arial"/>
                        </a:rPr>
                        <a:t>1504</a:t>
                      </a:r>
                      <a:endParaRPr sz="50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ts val="545"/>
                        </a:lnSpc>
                        <a:spcBef>
                          <a:spcPts val="55"/>
                        </a:spcBef>
                      </a:pPr>
                      <a:r>
                        <a:rPr sz="500" dirty="0">
                          <a:latin typeface="Arial"/>
                          <a:cs typeface="Arial"/>
                        </a:rPr>
                        <a:t>RPMI-1640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0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FCS,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dirty="0">
                          <a:latin typeface="Arial"/>
                          <a:cs typeface="Arial"/>
                        </a:rPr>
                        <a:t>1%</a:t>
                      </a:r>
                      <a:r>
                        <a:rPr sz="500" spc="10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(v/v)</a:t>
                      </a:r>
                      <a:r>
                        <a:rPr sz="500" spc="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500" spc="-10" dirty="0">
                          <a:latin typeface="Arial"/>
                          <a:cs typeface="Arial"/>
                        </a:rPr>
                        <a:t>Penicillin/Streptomycin</a:t>
                      </a:r>
                      <a:endParaRPr sz="500" dirty="0">
                        <a:latin typeface="Arial"/>
                        <a:cs typeface="Arial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7450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1</TotalTime>
  <Words>2502</Words>
  <Application>Microsoft Office PowerPoint</Application>
  <PresentationFormat>A4 Paper (210x297 mm)</PresentationFormat>
  <Paragraphs>412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sa Zanini</dc:creator>
  <cp:lastModifiedBy>Elisa Zanini</cp:lastModifiedBy>
  <cp:revision>5</cp:revision>
  <dcterms:created xsi:type="dcterms:W3CDTF">2023-10-19T16:11:37Z</dcterms:created>
  <dcterms:modified xsi:type="dcterms:W3CDTF">2024-05-23T09:43:49Z</dcterms:modified>
</cp:coreProperties>
</file>